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58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09" d="100"/>
          <a:sy n="109" d="100"/>
        </p:scale>
        <p:origin x="768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4DCD7A-5982-48BA-AE01-F06AF229A21C}" type="datetimeFigureOut">
              <a:rPr kumimoji="1" lang="ja-JP" altLang="en-US" smtClean="0"/>
              <a:pPr/>
              <a:t>2016/2/1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2603F7-1605-42C7-85C5-761A24C2865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920949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7828-9A13-4C09-9672-D38AD9F59621}" type="datetimeFigureOut">
              <a:rPr kumimoji="1" lang="ja-JP" altLang="en-US" smtClean="0"/>
              <a:pPr/>
              <a:t>2016/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77614-4F6C-4AFB-BCB5-E3C2DD9B53A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7828-9A13-4C09-9672-D38AD9F59621}" type="datetimeFigureOut">
              <a:rPr kumimoji="1" lang="ja-JP" altLang="en-US" smtClean="0"/>
              <a:pPr/>
              <a:t>2016/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77614-4F6C-4AFB-BCB5-E3C2DD9B53A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7828-9A13-4C09-9672-D38AD9F59621}" type="datetimeFigureOut">
              <a:rPr kumimoji="1" lang="ja-JP" altLang="en-US" smtClean="0"/>
              <a:pPr/>
              <a:t>2016/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77614-4F6C-4AFB-BCB5-E3C2DD9B53A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7828-9A13-4C09-9672-D38AD9F59621}" type="datetimeFigureOut">
              <a:rPr kumimoji="1" lang="ja-JP" altLang="en-US" smtClean="0"/>
              <a:pPr/>
              <a:t>2016/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77614-4F6C-4AFB-BCB5-E3C2DD9B53A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7828-9A13-4C09-9672-D38AD9F59621}" type="datetimeFigureOut">
              <a:rPr kumimoji="1" lang="ja-JP" altLang="en-US" smtClean="0"/>
              <a:pPr/>
              <a:t>2016/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77614-4F6C-4AFB-BCB5-E3C2DD9B53A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7828-9A13-4C09-9672-D38AD9F59621}" type="datetimeFigureOut">
              <a:rPr kumimoji="1" lang="ja-JP" altLang="en-US" smtClean="0"/>
              <a:pPr/>
              <a:t>2016/2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77614-4F6C-4AFB-BCB5-E3C2DD9B53A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7828-9A13-4C09-9672-D38AD9F59621}" type="datetimeFigureOut">
              <a:rPr kumimoji="1" lang="ja-JP" altLang="en-US" smtClean="0"/>
              <a:pPr/>
              <a:t>2016/2/1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77614-4F6C-4AFB-BCB5-E3C2DD9B53A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7828-9A13-4C09-9672-D38AD9F59621}" type="datetimeFigureOut">
              <a:rPr kumimoji="1" lang="ja-JP" altLang="en-US" smtClean="0"/>
              <a:pPr/>
              <a:t>2016/2/1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77614-4F6C-4AFB-BCB5-E3C2DD9B53A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7828-9A13-4C09-9672-D38AD9F59621}" type="datetimeFigureOut">
              <a:rPr kumimoji="1" lang="ja-JP" altLang="en-US" smtClean="0"/>
              <a:pPr/>
              <a:t>2016/2/1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77614-4F6C-4AFB-BCB5-E3C2DD9B53A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7828-9A13-4C09-9672-D38AD9F59621}" type="datetimeFigureOut">
              <a:rPr kumimoji="1" lang="ja-JP" altLang="en-US" smtClean="0"/>
              <a:pPr/>
              <a:t>2016/2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77614-4F6C-4AFB-BCB5-E3C2DD9B53A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7828-9A13-4C09-9672-D38AD9F59621}" type="datetimeFigureOut">
              <a:rPr kumimoji="1" lang="ja-JP" altLang="en-US" smtClean="0"/>
              <a:pPr/>
              <a:t>2016/2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77614-4F6C-4AFB-BCB5-E3C2DD9B53A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997828-9A13-4C09-9672-D38AD9F59621}" type="datetimeFigureOut">
              <a:rPr kumimoji="1" lang="ja-JP" altLang="en-US" smtClean="0"/>
              <a:pPr/>
              <a:t>2016/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E77614-4F6C-4AFB-BCB5-E3C2DD9B53A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openxmlformats.org/officeDocument/2006/relationships/image" Target="../media/image14.png"/><Relationship Id="rId18" Type="http://schemas.openxmlformats.org/officeDocument/2006/relationships/oleObject" Target="../embeddings/oleObject2.bin"/><Relationship Id="rId3" Type="http://schemas.openxmlformats.org/officeDocument/2006/relationships/image" Target="../media/image4.png"/><Relationship Id="rId21" Type="http://schemas.openxmlformats.org/officeDocument/2006/relationships/image" Target="../media/image3.wmf"/><Relationship Id="rId7" Type="http://schemas.openxmlformats.org/officeDocument/2006/relationships/image" Target="../media/image8.png"/><Relationship Id="rId12" Type="http://schemas.openxmlformats.org/officeDocument/2006/relationships/image" Target="../media/image13.png"/><Relationship Id="rId17" Type="http://schemas.openxmlformats.org/officeDocument/2006/relationships/image" Target="../media/image1.w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1.bin"/><Relationship Id="rId20" Type="http://schemas.openxmlformats.org/officeDocument/2006/relationships/oleObject" Target="../embeddings/oleObject3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7.png"/><Relationship Id="rId11" Type="http://schemas.openxmlformats.org/officeDocument/2006/relationships/image" Target="../media/image12.png"/><Relationship Id="rId5" Type="http://schemas.openxmlformats.org/officeDocument/2006/relationships/image" Target="../media/image6.png"/><Relationship Id="rId15" Type="http://schemas.openxmlformats.org/officeDocument/2006/relationships/image" Target="../media/image16.png"/><Relationship Id="rId10" Type="http://schemas.openxmlformats.org/officeDocument/2006/relationships/image" Target="../media/image11.png"/><Relationship Id="rId19" Type="http://schemas.openxmlformats.org/officeDocument/2006/relationships/image" Target="../media/image2.wmf"/><Relationship Id="rId4" Type="http://schemas.openxmlformats.org/officeDocument/2006/relationships/image" Target="../media/image5.png"/><Relationship Id="rId9" Type="http://schemas.openxmlformats.org/officeDocument/2006/relationships/image" Target="../media/image10.png"/><Relationship Id="rId14" Type="http://schemas.openxmlformats.org/officeDocument/2006/relationships/image" Target="../media/image15.png"/><Relationship Id="rId22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4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48366" y="167880"/>
            <a:ext cx="2500330" cy="1052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5365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063010" y="167880"/>
            <a:ext cx="2542661" cy="10572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5367" name="Picture 7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787344" y="205612"/>
            <a:ext cx="2500330" cy="10276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5368" name="Picture 8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074077" y="1462555"/>
            <a:ext cx="2551176" cy="10191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5370" name="Picture 10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3096347" y="2729754"/>
            <a:ext cx="2549145" cy="10715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5371" name="Picture 11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348366" y="2729755"/>
            <a:ext cx="2531003" cy="10715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5372" name="Picture 12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5786445" y="2734517"/>
            <a:ext cx="2500331" cy="10668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5375" name="Picture 15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5810259" y="4014905"/>
            <a:ext cx="2484422" cy="10620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5376" name="Picture 16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326575" y="5257562"/>
            <a:ext cx="2548497" cy="10788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5377" name="Picture 17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3108072" y="5257562"/>
            <a:ext cx="2500330" cy="10788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5378" name="Picture 18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5804030" y="5257562"/>
            <a:ext cx="2500330" cy="10715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6" name="テキスト ボックス 35"/>
          <p:cNvSpPr txBox="1"/>
          <p:nvPr/>
        </p:nvSpPr>
        <p:spPr>
          <a:xfrm>
            <a:off x="484280" y="-27384"/>
            <a:ext cx="64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/>
              <a:t>Case 1</a:t>
            </a:r>
            <a:endParaRPr kumimoji="1" lang="ja-JP" altLang="en-US" sz="1100" dirty="0"/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3220537" y="-27384"/>
            <a:ext cx="64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/>
              <a:t>Case 2</a:t>
            </a: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5934448" y="-27384"/>
            <a:ext cx="64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/>
              <a:t>Case 3</a:t>
            </a:r>
            <a:endParaRPr kumimoji="1" lang="ja-JP" altLang="en-US" sz="1100" dirty="0"/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484280" y="1247418"/>
            <a:ext cx="64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/>
              <a:t>Case 4</a:t>
            </a:r>
            <a:endParaRPr kumimoji="1" lang="ja-JP" altLang="en-US" sz="1100" dirty="0"/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3253875" y="1247418"/>
            <a:ext cx="64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/>
              <a:t>Case 5</a:t>
            </a: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5934448" y="1247418"/>
            <a:ext cx="64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/>
              <a:t>Case 6</a:t>
            </a:r>
            <a:endParaRPr kumimoji="1" lang="ja-JP" altLang="en-US" sz="1100" dirty="0"/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484280" y="2522220"/>
            <a:ext cx="64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/>
              <a:t>Case 7</a:t>
            </a:r>
            <a:endParaRPr kumimoji="1" lang="ja-JP" altLang="en-US" sz="1100" dirty="0"/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3253875" y="2522220"/>
            <a:ext cx="64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/>
              <a:t>Case 8</a:t>
            </a: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5934448" y="2522220"/>
            <a:ext cx="64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/>
              <a:t>Case 9</a:t>
            </a:r>
            <a:endParaRPr kumimoji="1" lang="ja-JP" altLang="en-US" sz="1100" dirty="0"/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484280" y="3797022"/>
            <a:ext cx="64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/>
              <a:t>Case 10</a:t>
            </a:r>
            <a:endParaRPr kumimoji="1" lang="ja-JP" altLang="en-US" sz="1100" dirty="0"/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3253875" y="3797022"/>
            <a:ext cx="64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/>
              <a:t>Case 11</a:t>
            </a: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5934448" y="3797022"/>
            <a:ext cx="64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/>
              <a:t>Case 12</a:t>
            </a:r>
            <a:endParaRPr kumimoji="1" lang="ja-JP" altLang="en-US" sz="1100" dirty="0"/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484280" y="5071823"/>
            <a:ext cx="64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/>
              <a:t>Case 13</a:t>
            </a:r>
            <a:endParaRPr kumimoji="1" lang="ja-JP" altLang="en-US" sz="1100" dirty="0"/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3253875" y="5071823"/>
            <a:ext cx="64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/>
              <a:t>Case 14</a:t>
            </a: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5934448" y="5071823"/>
            <a:ext cx="64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/>
              <a:t>Case 15</a:t>
            </a:r>
            <a:endParaRPr kumimoji="1" lang="ja-JP" altLang="en-US" sz="1100" dirty="0"/>
          </a:p>
        </p:txBody>
      </p:sp>
      <p:pic>
        <p:nvPicPr>
          <p:cNvPr id="15361" name="Picture 1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5782884" y="1436764"/>
            <a:ext cx="2461524" cy="109337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3" name="テキスト ボックス 32"/>
          <p:cNvSpPr txBox="1"/>
          <p:nvPr/>
        </p:nvSpPr>
        <p:spPr>
          <a:xfrm>
            <a:off x="5364088" y="6441147"/>
            <a:ext cx="35358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1. Ozawa et al.</a:t>
            </a:r>
            <a:endParaRPr kumimoji="1" lang="ja-JP" altLang="en-US" dirty="0"/>
          </a:p>
        </p:txBody>
      </p:sp>
      <p:pic>
        <p:nvPicPr>
          <p:cNvPr id="34" name="Picture 6"/>
          <p:cNvPicPr>
            <a:picLocks noChangeAspect="1" noChangeArrowheads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>
            <a:off x="369604" y="1460114"/>
            <a:ext cx="2479092" cy="10085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aphicFrame>
        <p:nvGraphicFramePr>
          <p:cNvPr id="56" name="オブジェクト 5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6770793"/>
              </p:ext>
            </p:extLst>
          </p:nvPr>
        </p:nvGraphicFramePr>
        <p:xfrm>
          <a:off x="412012" y="4017100"/>
          <a:ext cx="2462388" cy="9104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6" r:id="rId16" imgW="5825520" imgH="2154960" progId="">
                  <p:embed/>
                </p:oleObj>
              </mc:Choice>
              <mc:Fallback>
                <p:oleObj r:id="rId16" imgW="5825520" imgH="215496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412012" y="4017100"/>
                        <a:ext cx="2462388" cy="91047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7" name="オブジェクト 5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84159780"/>
              </p:ext>
            </p:extLst>
          </p:nvPr>
        </p:nvGraphicFramePr>
        <p:xfrm>
          <a:off x="500709" y="4949306"/>
          <a:ext cx="2343099" cy="1657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7" r:id="rId18" imgW="5721120" imgH="404640" progId="">
                  <p:embed/>
                </p:oleObj>
              </mc:Choice>
              <mc:Fallback>
                <p:oleObj r:id="rId18" imgW="5721120" imgH="4046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500709" y="4949306"/>
                        <a:ext cx="2343099" cy="1657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8" name="オブジェクト 5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25118451"/>
              </p:ext>
            </p:extLst>
          </p:nvPr>
        </p:nvGraphicFramePr>
        <p:xfrm>
          <a:off x="3204515" y="4038018"/>
          <a:ext cx="2393182" cy="8884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8" r:id="rId20" imgW="5734080" imgH="2129040" progId="">
                  <p:embed/>
                </p:oleObj>
              </mc:Choice>
              <mc:Fallback>
                <p:oleObj r:id="rId20" imgW="5734080" imgH="21290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3204515" y="4038018"/>
                        <a:ext cx="2393182" cy="8884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9" name="オブジェクト 5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5700018"/>
              </p:ext>
            </p:extLst>
          </p:nvPr>
        </p:nvGraphicFramePr>
        <p:xfrm>
          <a:off x="3292322" y="4957736"/>
          <a:ext cx="2308355" cy="1633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9" r:id="rId22" imgW="5721120" imgH="404640" progId="">
                  <p:embed/>
                </p:oleObj>
              </mc:Choice>
              <mc:Fallback>
                <p:oleObj r:id="rId22" imgW="5721120" imgH="4046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3292322" y="4957736"/>
                        <a:ext cx="2308355" cy="1633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9</TotalTime>
  <Words>38</Words>
  <Application>Microsoft Office PowerPoint</Application>
  <PresentationFormat>画面に合わせる (4:3)</PresentationFormat>
  <Paragraphs>16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0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nobu</dc:creator>
  <cp:lastModifiedBy>小澤伸晃</cp:lastModifiedBy>
  <cp:revision>58</cp:revision>
  <dcterms:created xsi:type="dcterms:W3CDTF">2011-08-08T06:01:23Z</dcterms:created>
  <dcterms:modified xsi:type="dcterms:W3CDTF">2016-02-12T06:09:12Z</dcterms:modified>
</cp:coreProperties>
</file>